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01007-5574-48AA-B466-A847058996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5B94B-96F1-4836-B659-AF0D6C54DD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673FD-19CE-40F3-BCBD-820876A8EB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3CA8F-7A64-4983-9765-5251FA9DB6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BB39D-4DFA-4C1E-A04C-D4BC277637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02528-0C17-4ACC-A700-2B1E3557C8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F2E10-0D25-43D0-B483-6FC33FA2B4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DF851-3402-4D67-976C-DBFF70A51C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44A10-9A0D-4E52-AE3F-639FF33A72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3F622-81F7-489D-8002-1E68762C61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F30F2-04A3-422A-8F5F-BB58BD06E3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3B033-5521-46C4-A433-82D991ADA2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SG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SG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4E4F30-462B-4ECE-843A-D6E91D869DA9}" type="slidenum">
              <a:rPr b="0" lang="en-SG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Singapore Climate Graph"/>
          <p:cNvPicPr/>
          <p:nvPr/>
        </p:nvPicPr>
        <p:blipFill>
          <a:blip r:embed="rId1"/>
          <a:stretch/>
        </p:blipFill>
        <p:spPr>
          <a:xfrm>
            <a:off x="476280" y="920880"/>
            <a:ext cx="5632560" cy="47592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6"/>
          <p:cNvSpPr/>
          <p:nvPr/>
        </p:nvSpPr>
        <p:spPr>
          <a:xfrm>
            <a:off x="274680" y="5680080"/>
            <a:ext cx="6107040" cy="29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data file 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Singapore climate graph. The data were achieved on 2 January 2013 from http://www.singapore.climatemps.com/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average temperature in Singapore, Singapore is 27.0 °C (81 °F)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range of average monthly temperatures is 1 °C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warmest average max/ high temperature is 31 °C (88 °F) in February, March, April, May, June &amp; July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coolest average min/ low temperature is 23 °C (73 °F) in January, February, October, November &amp; December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ngapore receives on average 2282 mm (89.8 in) of precipitation annually or 190 mm (7.5 in) each month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 balance there are 179 days annually on which greater than 0.1 mm (0.004 in) of precipitation (rain, sleet, snow or hail) occurs or 15 days on an average month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month with the driest weather is September when on balance 122 mm (4.8 in) of rain, sleet, hail or snow falls across 14 day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month with the wettest weather is December when on balance 306 mm (12.0 in) of rain, sleet, hail or snow falls across 19 day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n relative humidity for an average year is recorded as 80.4% and on a monthly basis it ranges from 79% in February, March &amp; June to 82% in January, November &amp; December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urs of sunshine range between 4.5 hours per day in December and 6.4 hours per day in February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 balance there are 2064 sunshine hours annually and approximately 5.7 sunlight hours for each day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SG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 balance there are 0 days annually with measurable frost and in January there are on average 0 days with frost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4T05:43:47Z</dcterms:created>
  <dc:creator>Jiang Shu Ye</dc:creator>
  <dc:description/>
  <dc:language>en-US</dc:language>
  <cp:lastModifiedBy>Jiang Shu Ye</cp:lastModifiedBy>
  <dcterms:modified xsi:type="dcterms:W3CDTF">2013-01-04T07:55:01Z</dcterms:modified>
  <cp:revision>7</cp:revision>
  <dc:subject/>
  <dc:title>PowerPoint Presentation</dc:title>
</cp:coreProperties>
</file>